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62" r:id="rId2"/>
  </p:sldIdLst>
  <p:sldSz cx="9906000" cy="6858000" type="A4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/>
    <p:restoredTop sz="94650"/>
  </p:normalViewPr>
  <p:slideViewPr>
    <p:cSldViewPr snapToGrid="0" snapToObjects="1" showGuides="1">
      <p:cViewPr varScale="1">
        <p:scale>
          <a:sx n="200" d="100"/>
          <a:sy n="200" d="100"/>
        </p:scale>
        <p:origin x="176" y="32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7639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895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325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6279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5230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320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630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6759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2827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9110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825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B7C8E-9754-AD4B-B733-507DD51F9CA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ED8CD8-14DE-8843-B732-5A957893606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3724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3"/>
          <p:cNvGraphicFramePr>
            <a:graphicFrameLocks noGrp="1"/>
          </p:cNvGraphicFramePr>
          <p:nvPr/>
        </p:nvGraphicFramePr>
        <p:xfrm>
          <a:off x="2615825" y="1393798"/>
          <a:ext cx="5507095" cy="209651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65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42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69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318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575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2999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ntibody</a:t>
                      </a:r>
                      <a:endParaRPr lang="sv-SE" sz="1600" dirty="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lone name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ilution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roduct code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upplier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mmunostainer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D1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P67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Prediluted</a:t>
                      </a:r>
                      <a:endParaRPr lang="sv-SE" sz="1600" dirty="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5857856001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R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B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K19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17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:10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NCL-CK19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NCL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B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-cadherin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6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rediluted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5905290001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R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B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Ki-67</a:t>
                      </a:r>
                      <a:endParaRPr lang="sv-SE" sz="1600" dirty="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IB-1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:10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724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K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B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imentin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9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:150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0725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DK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B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9502">
                <a:tc>
                  <a:txBody>
                    <a:bodyPr/>
                    <a:lstStyle/>
                    <a:p>
                      <a:pPr marL="9525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WT-1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5334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F-H2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6096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:100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48M-96</a:t>
                      </a:r>
                      <a:endParaRPr lang="sv-SE" sz="1600" dirty="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M</a:t>
                      </a:r>
                      <a:endParaRPr lang="sv-SE" sz="160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18110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LB</a:t>
                      </a:r>
                      <a:endParaRPr lang="sv-SE" sz="1600" dirty="0">
                        <a:effectLst/>
                        <a:latin typeface="Calibri" panose="020F0502020204030204" pitchFamily="34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603948" y="1143695"/>
            <a:ext cx="4186295" cy="2501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74295" tIns="37148" rIns="74295" bIns="37148" numCol="1" anchor="ctr" anchorCtr="0" compatLnSpc="1">
            <a:prstTxWarp prst="textNoShape">
              <a:avLst/>
            </a:prstTxWarp>
            <a:spAutoFit/>
          </a:bodyPr>
          <a:lstStyle/>
          <a:p>
            <a:pPr defTabSz="74295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bodies used for immunohistochemical analysis.</a:t>
            </a:r>
            <a:r>
              <a:rPr lang="en-US" altLang="sv-SE" sz="1138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 </a:t>
            </a:r>
            <a:endParaRPr lang="sv-SE" altLang="sv-SE" sz="1138" dirty="0"/>
          </a:p>
        </p:txBody>
      </p:sp>
      <p:sp>
        <p:nvSpPr>
          <p:cNvPr id="8" name="textruta 7"/>
          <p:cNvSpPr txBox="1"/>
          <p:nvPr/>
        </p:nvSpPr>
        <p:spPr>
          <a:xfrm>
            <a:off x="2607570" y="3902352"/>
            <a:ext cx="4534575" cy="1968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u="sng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body suppliers</a:t>
            </a: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: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M: Cell Marque, California, United States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sv-SE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DK: </a:t>
            </a:r>
            <a:r>
              <a:rPr lang="sv-SE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Dako</a:t>
            </a:r>
            <a:r>
              <a:rPr lang="sv-SE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- Agilent: </a:t>
            </a:r>
            <a:r>
              <a:rPr lang="sv-SE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Dako</a:t>
            </a:r>
            <a:r>
              <a:rPr lang="sv-SE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Glostrup, </a:t>
            </a:r>
            <a:r>
              <a:rPr lang="sv-SE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Denmark</a:t>
            </a:r>
            <a:r>
              <a:rPr lang="sv-SE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NCL: </a:t>
            </a:r>
            <a:r>
              <a:rPr lang="en-US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Novocastra</a:t>
            </a: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Leica Biosystems Ltd, Newcastle Upon Tyne, United Kingdom.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VR: </a:t>
            </a:r>
            <a:r>
              <a:rPr lang="en-US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Ventana</a:t>
            </a: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Roche, Arizona, United States.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endParaRPr lang="fr-FR" altLang="sv-SE" sz="1138" u="sng" dirty="0">
              <a:latin typeface="Times New Roman" panose="02020603050405020304" pitchFamily="18" charset="0"/>
              <a:ea typeface="MS Mincho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sv-SE" sz="1138" u="sng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utomated immunostainer</a:t>
            </a:r>
            <a:r>
              <a:rPr lang="fr-FR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: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VB: </a:t>
            </a:r>
            <a:r>
              <a:rPr lang="en-US" altLang="sv-SE" sz="1138" dirty="0" err="1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Ventana</a:t>
            </a: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Benchmark Ultra</a:t>
            </a:r>
            <a:endParaRPr lang="sv-SE" altLang="sv-SE" sz="1138" dirty="0"/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sv-SE" sz="1138" dirty="0"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LB: Leica BOND III</a:t>
            </a:r>
            <a:endParaRPr lang="sv-SE" altLang="sv-SE" sz="1138" dirty="0"/>
          </a:p>
          <a:p>
            <a:endParaRPr lang="sv-SE" sz="813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534307A-81CF-7747-8993-E3B09D5E8317}"/>
              </a:ext>
            </a:extLst>
          </p:cNvPr>
          <p:cNvSpPr/>
          <p:nvPr/>
        </p:nvSpPr>
        <p:spPr>
          <a:xfrm>
            <a:off x="87012" y="718612"/>
            <a:ext cx="1866601" cy="4424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sv-SE" sz="2275" b="1" dirty="0">
                <a:ea typeface="MS Mincho"/>
                <a:cs typeface="Times New Roman" panose="02020603050405020304" pitchFamily="18" charset="0"/>
              </a:rPr>
              <a:t>Suppl. Table 1</a:t>
            </a:r>
            <a:endParaRPr lang="en-US" sz="2275" dirty="0"/>
          </a:p>
        </p:txBody>
      </p:sp>
    </p:spTree>
    <p:extLst>
      <p:ext uri="{BB962C8B-B14F-4D97-AF65-F5344CB8AC3E}">
        <p14:creationId xmlns:p14="http://schemas.microsoft.com/office/powerpoint/2010/main" val="930015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6</Words>
  <Application>Microsoft Macintosh PowerPoint</Application>
  <PresentationFormat>A4 Paper (210x297 mm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er Heuchel</dc:creator>
  <cp:lastModifiedBy>Rainer Heuchel</cp:lastModifiedBy>
  <cp:revision>2</cp:revision>
  <dcterms:created xsi:type="dcterms:W3CDTF">2020-03-20T15:51:43Z</dcterms:created>
  <dcterms:modified xsi:type="dcterms:W3CDTF">2020-04-12T15:26:12Z</dcterms:modified>
</cp:coreProperties>
</file>